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54C3E-E254-4E42-921B-FF6FE69320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0F1CC-A110-41E3-A7E7-85A456B3A6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A860B-951D-453F-8A81-264BAC4D46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961CE-6590-4F40-9439-F084D1891B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C8286-DCA9-4D0E-AAFD-0D597A4476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3FD03-F84D-4AD1-893E-EEB1142196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42CA9-EF0E-4CE1-8AEC-0CA672C213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C855D-AF0D-4E96-9148-1C7671970A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DF56E-9BC4-4483-9E76-86F0626D0E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71BB3-DF83-4082-B5C6-EB4A6362B0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96F26-0B6A-455F-ABC6-CE500FB5D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3A05D-4B77-4C8E-9B86-0D60E7E341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FA5C42-F811-42E0-95C4-9C0F0948434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8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9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0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1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457200" y="677880"/>
            <a:ext cx="61722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Lege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Fig 1: Circulating levels of pancreatic and gut hormones in the follow up samples. Bar-graph showing follow up levels of insul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glucago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ghrel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GIP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GLP-1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in the  serum of NMS-LF+ and MS-LF+ subjec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Fig 2: Circulating levels of adipokines in the follow up samples. Bar-graph showing follow up levels of adiponect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lept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resist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adips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PAI-1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visfat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in the serum of NMS-LF+ and MS-LF+ subjec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Object 2"/>
          <p:cNvGraphicFramePr/>
          <p:nvPr/>
        </p:nvGraphicFramePr>
        <p:xfrm>
          <a:off x="601560" y="1925640"/>
          <a:ext cx="2613240" cy="23781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1560" y="1925640"/>
                    <a:ext cx="2613240" cy="2378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Box 13"/>
          <p:cNvSpPr/>
          <p:nvPr/>
        </p:nvSpPr>
        <p:spPr>
          <a:xfrm>
            <a:off x="152280" y="1320840"/>
            <a:ext cx="106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Fig 1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"/>
          <p:cNvSpPr/>
          <p:nvPr/>
        </p:nvSpPr>
        <p:spPr>
          <a:xfrm>
            <a:off x="5638680" y="1244520"/>
            <a:ext cx="152640" cy="1526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6"/>
          <p:cNvSpPr/>
          <p:nvPr/>
        </p:nvSpPr>
        <p:spPr>
          <a:xfrm>
            <a:off x="5791320" y="116856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F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5"/>
          <p:cNvSpPr/>
          <p:nvPr/>
        </p:nvSpPr>
        <p:spPr>
          <a:xfrm>
            <a:off x="5638680" y="1473120"/>
            <a:ext cx="152640" cy="152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8"/>
          <p:cNvSpPr/>
          <p:nvPr/>
        </p:nvSpPr>
        <p:spPr>
          <a:xfrm>
            <a:off x="5791320" y="139716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F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3"/>
          <p:cNvGraphicFramePr/>
          <p:nvPr/>
        </p:nvGraphicFramePr>
        <p:xfrm>
          <a:off x="3562200" y="1930320"/>
          <a:ext cx="2784600" cy="2368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0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562200" y="1930320"/>
                    <a:ext cx="2784600" cy="2368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4"/>
          <p:cNvGraphicFramePr/>
          <p:nvPr/>
        </p:nvGraphicFramePr>
        <p:xfrm>
          <a:off x="20520" y="5207040"/>
          <a:ext cx="2319480" cy="21081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2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0520" y="5207040"/>
                    <a:ext cx="2319480" cy="2108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Object 5"/>
          <p:cNvGraphicFramePr/>
          <p:nvPr/>
        </p:nvGraphicFramePr>
        <p:xfrm>
          <a:off x="2349360" y="5207040"/>
          <a:ext cx="2241720" cy="21034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4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349360" y="5207040"/>
                    <a:ext cx="2241720" cy="210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Object 6"/>
          <p:cNvGraphicFramePr/>
          <p:nvPr/>
        </p:nvGraphicFramePr>
        <p:xfrm>
          <a:off x="4608360" y="5203800"/>
          <a:ext cx="2257560" cy="21067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6" name="Object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608360" y="5203800"/>
                    <a:ext cx="2257560" cy="210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13"/>
          <p:cNvSpPr/>
          <p:nvPr/>
        </p:nvSpPr>
        <p:spPr>
          <a:xfrm>
            <a:off x="152280" y="380880"/>
            <a:ext cx="106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Fig 2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"/>
          <p:cNvSpPr/>
          <p:nvPr/>
        </p:nvSpPr>
        <p:spPr>
          <a:xfrm>
            <a:off x="5638680" y="304920"/>
            <a:ext cx="152640" cy="152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6"/>
          <p:cNvSpPr/>
          <p:nvPr/>
        </p:nvSpPr>
        <p:spPr>
          <a:xfrm>
            <a:off x="5791320" y="22860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F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6"/>
          <p:cNvSpPr/>
          <p:nvPr/>
        </p:nvSpPr>
        <p:spPr>
          <a:xfrm>
            <a:off x="5638680" y="533520"/>
            <a:ext cx="152640" cy="152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8"/>
          <p:cNvSpPr/>
          <p:nvPr/>
        </p:nvSpPr>
        <p:spPr>
          <a:xfrm>
            <a:off x="5791320" y="45720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F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Object 4"/>
          <p:cNvGraphicFramePr/>
          <p:nvPr/>
        </p:nvGraphicFramePr>
        <p:xfrm>
          <a:off x="520560" y="906480"/>
          <a:ext cx="2617920" cy="2577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20560" y="906480"/>
                    <a:ext cx="2617920" cy="257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4" name="Object 5"/>
          <p:cNvGraphicFramePr/>
          <p:nvPr/>
        </p:nvGraphicFramePr>
        <p:xfrm>
          <a:off x="3645000" y="907920"/>
          <a:ext cx="2720880" cy="2603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5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645000" y="907920"/>
                    <a:ext cx="2720880" cy="2603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Object 6"/>
          <p:cNvGraphicFramePr/>
          <p:nvPr/>
        </p:nvGraphicFramePr>
        <p:xfrm>
          <a:off x="365040" y="3503520"/>
          <a:ext cx="3094200" cy="2563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7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65040" y="3503520"/>
                    <a:ext cx="3094200" cy="2563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Object 7"/>
          <p:cNvGraphicFramePr/>
          <p:nvPr/>
        </p:nvGraphicFramePr>
        <p:xfrm>
          <a:off x="3795840" y="3497400"/>
          <a:ext cx="2847960" cy="26082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9" name="Object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795840" y="3497400"/>
                    <a:ext cx="2847960" cy="260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Object 8"/>
          <p:cNvGraphicFramePr/>
          <p:nvPr/>
        </p:nvGraphicFramePr>
        <p:xfrm>
          <a:off x="447840" y="6477120"/>
          <a:ext cx="2990520" cy="22874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1" name="Object 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47840" y="6477120"/>
                    <a:ext cx="2990520" cy="228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Object 9"/>
          <p:cNvGraphicFramePr/>
          <p:nvPr/>
        </p:nvGraphicFramePr>
        <p:xfrm>
          <a:off x="3871800" y="6400800"/>
          <a:ext cx="2868840" cy="22860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3" name="Object 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871800" y="6400800"/>
                    <a:ext cx="2868840" cy="22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6-11T03:53:09Z</dcterms:created>
  <dc:creator>DELL</dc:creator>
  <dc:description/>
  <dc:language>en-US</dc:language>
  <cp:lastModifiedBy>Aravindhan</cp:lastModifiedBy>
  <dcterms:modified xsi:type="dcterms:W3CDTF">2022-10-30T18:21:43Z</dcterms:modified>
  <cp:revision>23</cp:revision>
  <dc:subject/>
  <dc:title>Slide 1</dc:title>
</cp:coreProperties>
</file>